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4BDD58CE-7F40-4D02-A814-294CBCED93DA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2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Schematic representation of methods. The simulated match required participants to complete “rounds” of intermittent exercise consisting of walking, sprinting, jogging, back pedalling and fast jogging. A round of exercise was repeated three times to make a “block” of activity. Seven blocks of activity, each separated by two min rest, equated to a 45 min half. B = block of intermittent exercise, R = round of intermittent exercise per block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39210465-3129-4247-A60A-4D6A1F052AC7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8DAEF7-A8BC-4662-B4D2-4BFAD292803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339141-D343-4C92-952D-5B28E3DD5C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CE4F99-03A7-47D3-8B57-7BCFA49CEAB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AC22AE-D826-4AE9-9753-F43C4259D7E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F06FD-BAAF-4A83-9C29-C464AE05C2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3AF004-C648-4596-8AD7-FDFED7F9AB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19787C-9D3F-42E6-B50A-CD426AA867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42DD8D-9FA9-406A-82B6-EE95E34F7B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043BA9-2D74-48B4-861A-8B68C65BA0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E97A0-7B22-4724-A0CB-01CFBF1F2B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FCF438-87D0-4BF2-ACBA-477A0D27B2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129611-B65A-4F90-B728-E0DB34AA29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1280" indent="-3412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1240" indent="-2840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1560" indent="-2271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598760" indent="-2271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5960" indent="-22716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fld id="{E2120A14-0CE3-434A-9688-F5887ED7A34C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Straight Connector 4"/>
          <p:cNvSpPr/>
          <p:nvPr/>
        </p:nvSpPr>
        <p:spPr>
          <a:xfrm>
            <a:off x="34920" y="1957320"/>
            <a:ext cx="8893080" cy="4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30"/>
          <p:cNvSpPr/>
          <p:nvPr/>
        </p:nvSpPr>
        <p:spPr>
          <a:xfrm>
            <a:off x="1168560" y="433440"/>
            <a:ext cx="87084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GB" sz="700" spc="-1" strike="noStrike">
                <a:solidFill>
                  <a:srgbClr val="000000"/>
                </a:solidFill>
                <a:latin typeface="Calibri"/>
              </a:rPr>
              <a:t>Motor nerve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GB" sz="700" spc="-1" strike="noStrike">
                <a:solidFill>
                  <a:srgbClr val="000000"/>
                </a:solidFill>
                <a:latin typeface="Calibri"/>
              </a:rPr>
              <a:t>Stimulation 100 Hz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34"/>
          <p:cNvSpPr/>
          <p:nvPr/>
        </p:nvSpPr>
        <p:spPr>
          <a:xfrm>
            <a:off x="45720" y="1189080"/>
            <a:ext cx="267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V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1" name="Group 36"/>
          <p:cNvGrpSpPr/>
          <p:nvPr/>
        </p:nvGrpSpPr>
        <p:grpSpPr>
          <a:xfrm>
            <a:off x="1463040" y="870120"/>
            <a:ext cx="267480" cy="1079280"/>
            <a:chOff x="1463040" y="870120"/>
            <a:chExt cx="267480" cy="1079280"/>
          </a:xfrm>
        </p:grpSpPr>
        <p:sp>
          <p:nvSpPr>
            <p:cNvPr id="52" name="Rectangle 37"/>
            <p:cNvSpPr/>
            <p:nvPr/>
          </p:nvSpPr>
          <p:spPr>
            <a:xfrm>
              <a:off x="1542960" y="870120"/>
              <a:ext cx="108000" cy="1079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38"/>
            <p:cNvSpPr/>
            <p:nvPr/>
          </p:nvSpPr>
          <p:spPr>
            <a:xfrm>
              <a:off x="1463040" y="1189440"/>
              <a:ext cx="2674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4" name="TextBox 54"/>
          <p:cNvSpPr/>
          <p:nvPr/>
        </p:nvSpPr>
        <p:spPr>
          <a:xfrm>
            <a:off x="1577160" y="1898640"/>
            <a:ext cx="32544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GB" sz="700" spc="-1" strike="noStrike">
                <a:solidFill>
                  <a:srgbClr val="000000"/>
                </a:solidFill>
                <a:latin typeface="Calibri"/>
              </a:rPr>
              <a:t>res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5" name="Group 182"/>
          <p:cNvGrpSpPr/>
          <p:nvPr/>
        </p:nvGrpSpPr>
        <p:grpSpPr>
          <a:xfrm>
            <a:off x="2109240" y="433440"/>
            <a:ext cx="845280" cy="1520640"/>
            <a:chOff x="2109240" y="433440"/>
            <a:chExt cx="845280" cy="1520640"/>
          </a:xfrm>
        </p:grpSpPr>
        <p:sp>
          <p:nvSpPr>
            <p:cNvPr id="56" name="TextBox 61"/>
            <p:cNvSpPr/>
            <p:nvPr/>
          </p:nvSpPr>
          <p:spPr>
            <a:xfrm>
              <a:off x="2198160" y="433440"/>
              <a:ext cx="666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Motor cortex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stimulation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7" name="Group 55"/>
            <p:cNvGrpSpPr/>
            <p:nvPr/>
          </p:nvGrpSpPr>
          <p:grpSpPr>
            <a:xfrm>
              <a:off x="2109240" y="869400"/>
              <a:ext cx="267480" cy="1080360"/>
              <a:chOff x="2109240" y="869400"/>
              <a:chExt cx="267480" cy="1080360"/>
            </a:xfrm>
          </p:grpSpPr>
          <p:sp>
            <p:nvSpPr>
              <p:cNvPr id="58" name="Rectangle 56"/>
              <p:cNvSpPr/>
              <p:nvPr/>
            </p:nvSpPr>
            <p:spPr>
              <a:xfrm>
                <a:off x="2179800" y="869400"/>
                <a:ext cx="117360" cy="108036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TextBox 57"/>
              <p:cNvSpPr/>
              <p:nvPr/>
            </p:nvSpPr>
            <p:spPr>
              <a:xfrm>
                <a:off x="2109240" y="1189080"/>
                <a:ext cx="2674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V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C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0" name="Group 58"/>
            <p:cNvGrpSpPr/>
            <p:nvPr/>
          </p:nvGrpSpPr>
          <p:grpSpPr>
            <a:xfrm>
              <a:off x="2388960" y="1139760"/>
              <a:ext cx="284400" cy="810360"/>
              <a:chOff x="2388960" y="1139760"/>
              <a:chExt cx="284400" cy="810360"/>
            </a:xfrm>
          </p:grpSpPr>
          <p:sp>
            <p:nvSpPr>
              <p:cNvPr id="61" name="Rectangle 59"/>
              <p:cNvSpPr/>
              <p:nvPr/>
            </p:nvSpPr>
            <p:spPr>
              <a:xfrm>
                <a:off x="2476440" y="1139760"/>
                <a:ext cx="109440" cy="81036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TextBox 60"/>
              <p:cNvSpPr/>
              <p:nvPr/>
            </p:nvSpPr>
            <p:spPr>
              <a:xfrm>
                <a:off x="2388960" y="1395000"/>
                <a:ext cx="2844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7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%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3" name="Group 62"/>
            <p:cNvGrpSpPr/>
            <p:nvPr/>
          </p:nvGrpSpPr>
          <p:grpSpPr>
            <a:xfrm>
              <a:off x="2670120" y="1414080"/>
              <a:ext cx="284400" cy="540000"/>
              <a:chOff x="2670120" y="1414080"/>
              <a:chExt cx="284400" cy="540000"/>
            </a:xfrm>
          </p:grpSpPr>
          <p:sp>
            <p:nvSpPr>
              <p:cNvPr id="64" name="Rectangle 63"/>
              <p:cNvSpPr/>
              <p:nvPr/>
            </p:nvSpPr>
            <p:spPr>
              <a:xfrm>
                <a:off x="2757600" y="1414080"/>
                <a:ext cx="109440" cy="54000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TextBox 64"/>
              <p:cNvSpPr/>
              <p:nvPr/>
            </p:nvSpPr>
            <p:spPr>
              <a:xfrm>
                <a:off x="2670120" y="1497600"/>
                <a:ext cx="2844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%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6" name="Group 174"/>
            <p:cNvGrpSpPr/>
            <p:nvPr/>
          </p:nvGrpSpPr>
          <p:grpSpPr>
            <a:xfrm>
              <a:off x="2222280" y="759240"/>
              <a:ext cx="583920" cy="645120"/>
              <a:chOff x="2222280" y="759240"/>
              <a:chExt cx="583920" cy="645120"/>
            </a:xfrm>
          </p:grpSpPr>
          <p:cxnSp>
            <p:nvCxnSpPr>
              <p:cNvPr id="67" name="Straight Arrow Connector 176"/>
              <p:cNvCxnSpPr/>
              <p:nvPr/>
            </p:nvCxnSpPr>
            <p:spPr>
              <a:xfrm>
                <a:off x="2222280" y="759240"/>
                <a:ext cx="2160" cy="106920"/>
              </a:xfrm>
              <a:prstGeom prst="straightConnector1">
                <a:avLst/>
              </a:prstGeom>
              <a:ln w="648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68" name="Straight Arrow Connector 177"/>
              <p:cNvCxnSpPr/>
              <p:nvPr/>
            </p:nvCxnSpPr>
            <p:spPr>
              <a:xfrm>
                <a:off x="2521800" y="759240"/>
                <a:ext cx="1080" cy="375480"/>
              </a:xfrm>
              <a:prstGeom prst="straightConnector1">
                <a:avLst/>
              </a:prstGeom>
              <a:ln w="648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69" name="Straight Arrow Connector 178"/>
              <p:cNvCxnSpPr/>
              <p:nvPr/>
            </p:nvCxnSpPr>
            <p:spPr>
              <a:xfrm>
                <a:off x="2804400" y="759240"/>
                <a:ext cx="2160" cy="645480"/>
              </a:xfrm>
              <a:prstGeom prst="straightConnector1">
                <a:avLst/>
              </a:prstGeom>
              <a:ln w="6480">
                <a:solidFill>
                  <a:srgbClr val="000000"/>
                </a:solidFill>
                <a:miter/>
                <a:tailEnd len="sm" type="triangle" w="sm"/>
              </a:ln>
            </p:spPr>
          </p:cxnSp>
        </p:grpSp>
      </p:grpSp>
      <p:sp>
        <p:nvSpPr>
          <p:cNvPr id="70" name="Straight Connector 190"/>
          <p:cNvSpPr/>
          <p:nvPr/>
        </p:nvSpPr>
        <p:spPr>
          <a:xfrm flipH="1">
            <a:off x="1590480" y="752400"/>
            <a:ext cx="1537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1" name="Straight Arrow Connector 191"/>
          <p:cNvCxnSpPr/>
          <p:nvPr/>
        </p:nvCxnSpPr>
        <p:spPr>
          <a:xfrm>
            <a:off x="1595520" y="753840"/>
            <a:ext cx="2160" cy="1083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cxnSp>
        <p:nvCxnSpPr>
          <p:cNvPr id="72" name="Straight Arrow Connector 192"/>
          <p:cNvCxnSpPr/>
          <p:nvPr/>
        </p:nvCxnSpPr>
        <p:spPr>
          <a:xfrm>
            <a:off x="1749240" y="750960"/>
            <a:ext cx="1080" cy="11876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grpSp>
        <p:nvGrpSpPr>
          <p:cNvPr id="73" name="Group 209"/>
          <p:cNvGrpSpPr/>
          <p:nvPr/>
        </p:nvGrpSpPr>
        <p:grpSpPr>
          <a:xfrm>
            <a:off x="1917720" y="1876320"/>
            <a:ext cx="74520" cy="122400"/>
            <a:chOff x="1917720" y="1876320"/>
            <a:chExt cx="74520" cy="122400"/>
          </a:xfrm>
        </p:grpSpPr>
        <p:sp>
          <p:nvSpPr>
            <p:cNvPr id="74" name="Rounded Rectangle 211"/>
            <p:cNvSpPr/>
            <p:nvPr/>
          </p:nvSpPr>
          <p:spPr>
            <a:xfrm>
              <a:off x="1939680" y="1876320"/>
              <a:ext cx="36360" cy="122400"/>
            </a:xfrm>
            <a:custGeom>
              <a:avLst/>
              <a:gdLst>
                <a:gd name="textAreaLeft" fmla="*/ 1440 w 36360"/>
                <a:gd name="textAreaRight" fmla="*/ 34920 w 36360"/>
                <a:gd name="textAreaTop" fmla="*/ 1440 h 122400"/>
                <a:gd name="textAreaBottom" fmla="*/ 120960 h 122400"/>
              </a:gdLst>
              <a:ahLst/>
              <a:rect l="textAreaLeft" t="textAreaTop" r="textAreaRight" b="textAreaBottom"/>
              <a:pathLst>
                <a:path w="21600" h="72212">
                  <a:moveTo>
                    <a:pt x="3600" y="0"/>
                  </a:moveTo>
                  <a:arcTo wR="3600" hR="3600" stAng="16200000" swAng="-5400000"/>
                  <a:lnTo>
                    <a:pt x="0" y="68612"/>
                  </a:lnTo>
                  <a:arcTo wR="3600" hR="3600" stAng="10800000" swAng="-5400000"/>
                  <a:lnTo>
                    <a:pt x="18000" y="72212"/>
                  </a:lnTo>
                  <a:arcTo wR="3600" hR="3600" stAng="5400000" swAng="-5400000"/>
                  <a:lnTo>
                    <a:pt x="21600" y="3600"/>
                  </a:lnTo>
                  <a:arcTo wR="3600" hR="3600" stAng="0" swAng="-5400000"/>
                  <a:close/>
                </a:path>
              </a:pathLst>
            </a:cu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Straight Connector 212"/>
            <p:cNvSpPr/>
            <p:nvPr/>
          </p:nvSpPr>
          <p:spPr>
            <a:xfrm flipV="1">
              <a:off x="1917720" y="1901160"/>
              <a:ext cx="36360" cy="64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7280" bIns="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Straight Connector 213"/>
            <p:cNvSpPr/>
            <p:nvPr/>
          </p:nvSpPr>
          <p:spPr>
            <a:xfrm flipV="1">
              <a:off x="1955880" y="1902240"/>
              <a:ext cx="36360" cy="68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7" name="TextBox 210"/>
          <p:cNvSpPr/>
          <p:nvPr/>
        </p:nvSpPr>
        <p:spPr>
          <a:xfrm>
            <a:off x="1809000" y="1954080"/>
            <a:ext cx="304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GB" sz="600" spc="-1" strike="noStrike">
                <a:solidFill>
                  <a:srgbClr val="000000"/>
                </a:solidFill>
                <a:latin typeface="Calibri"/>
              </a:rPr>
              <a:t>90 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8" name="Group 214"/>
          <p:cNvGrpSpPr/>
          <p:nvPr/>
        </p:nvGrpSpPr>
        <p:grpSpPr>
          <a:xfrm>
            <a:off x="2795040" y="1884240"/>
            <a:ext cx="304200" cy="254520"/>
            <a:chOff x="2795040" y="1884240"/>
            <a:chExt cx="304200" cy="254520"/>
          </a:xfrm>
        </p:grpSpPr>
        <p:grpSp>
          <p:nvGrpSpPr>
            <p:cNvPr id="79" name="Group 215"/>
            <p:cNvGrpSpPr/>
            <p:nvPr/>
          </p:nvGrpSpPr>
          <p:grpSpPr>
            <a:xfrm>
              <a:off x="2927520" y="1884240"/>
              <a:ext cx="74160" cy="123480"/>
              <a:chOff x="2927520" y="1884240"/>
              <a:chExt cx="74160" cy="123480"/>
            </a:xfrm>
          </p:grpSpPr>
          <p:sp>
            <p:nvSpPr>
              <p:cNvPr id="80" name="Rounded Rectangle 217"/>
              <p:cNvSpPr/>
              <p:nvPr/>
            </p:nvSpPr>
            <p:spPr>
              <a:xfrm>
                <a:off x="2949480" y="1884240"/>
                <a:ext cx="36360" cy="123480"/>
              </a:xfrm>
              <a:custGeom>
                <a:avLst/>
                <a:gdLst>
                  <a:gd name="textAreaLeft" fmla="*/ 1440 w 36360"/>
                  <a:gd name="textAreaRight" fmla="*/ 34920 w 36360"/>
                  <a:gd name="textAreaTop" fmla="*/ 1440 h 123480"/>
                  <a:gd name="textAreaBottom" fmla="*/ 122040 h 123480"/>
                </a:gdLst>
                <a:ahLst/>
                <a:rect l="textAreaLeft" t="textAreaTop" r="textAreaRight" b="textAreaBottom"/>
                <a:pathLst>
                  <a:path w="21600" h="72847">
                    <a:moveTo>
                      <a:pt x="3600" y="0"/>
                    </a:moveTo>
                    <a:arcTo wR="3600" hR="3600" stAng="16200000" swAng="-5400000"/>
                    <a:lnTo>
                      <a:pt x="0" y="69247"/>
                    </a:lnTo>
                    <a:arcTo wR="3600" hR="3600" stAng="10800000" swAng="-5400000"/>
                    <a:lnTo>
                      <a:pt x="18000" y="72847"/>
                    </a:lnTo>
                    <a:arcTo wR="3600" hR="3600" stAng="5400000" swAng="-5400000"/>
                    <a:lnTo>
                      <a:pt x="21600" y="3600"/>
                    </a:lnTo>
                    <a:arcTo wR="3600" hR="3600" stAng="0" swAng="-5400000"/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Straight Connector 218"/>
              <p:cNvSpPr/>
              <p:nvPr/>
            </p:nvSpPr>
            <p:spPr>
              <a:xfrm flipV="1">
                <a:off x="2927520" y="1912680"/>
                <a:ext cx="36360" cy="71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Straight Connector 219"/>
              <p:cNvSpPr/>
              <p:nvPr/>
            </p:nvSpPr>
            <p:spPr>
              <a:xfrm flipV="1">
                <a:off x="2965320" y="1914120"/>
                <a:ext cx="36360" cy="727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3" name="TextBox 216"/>
            <p:cNvSpPr/>
            <p:nvPr/>
          </p:nvSpPr>
          <p:spPr>
            <a:xfrm>
              <a:off x="2795040" y="1953360"/>
              <a:ext cx="304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GB" sz="600" spc="-1" strike="noStrike">
                  <a:solidFill>
                    <a:srgbClr val="000000"/>
                  </a:solidFill>
                  <a:latin typeface="Calibri"/>
                </a:rPr>
                <a:t>90 s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4" name="Group 220"/>
          <p:cNvGrpSpPr/>
          <p:nvPr/>
        </p:nvGrpSpPr>
        <p:grpSpPr>
          <a:xfrm>
            <a:off x="3117240" y="1697040"/>
            <a:ext cx="915120" cy="307080"/>
            <a:chOff x="3117240" y="1697040"/>
            <a:chExt cx="915120" cy="307080"/>
          </a:xfrm>
        </p:grpSpPr>
        <p:sp>
          <p:nvSpPr>
            <p:cNvPr id="85" name="Rectangle 221"/>
            <p:cNvSpPr/>
            <p:nvPr/>
          </p:nvSpPr>
          <p:spPr>
            <a:xfrm>
              <a:off x="3141360" y="1738080"/>
              <a:ext cx="865440" cy="2160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222"/>
            <p:cNvSpPr/>
            <p:nvPr/>
          </p:nvSpPr>
          <p:spPr>
            <a:xfrm>
              <a:off x="3117240" y="1697040"/>
              <a:ext cx="91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Single and Paired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Pulse TMS 10% MV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7" name="TextBox 229"/>
          <p:cNvSpPr/>
          <p:nvPr/>
        </p:nvSpPr>
        <p:spPr>
          <a:xfrm>
            <a:off x="6445440" y="1187280"/>
            <a:ext cx="267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V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8" name="Group 231"/>
          <p:cNvGrpSpPr/>
          <p:nvPr/>
        </p:nvGrpSpPr>
        <p:grpSpPr>
          <a:xfrm>
            <a:off x="7119360" y="1192320"/>
            <a:ext cx="843840" cy="645120"/>
            <a:chOff x="7119360" y="1192320"/>
            <a:chExt cx="843840" cy="645120"/>
          </a:xfrm>
        </p:grpSpPr>
        <p:sp>
          <p:nvSpPr>
            <p:cNvPr id="89" name="TextBox 246"/>
            <p:cNvSpPr/>
            <p:nvPr/>
          </p:nvSpPr>
          <p:spPr>
            <a:xfrm>
              <a:off x="7119360" y="1192320"/>
              <a:ext cx="2674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242"/>
            <p:cNvSpPr/>
            <p:nvPr/>
          </p:nvSpPr>
          <p:spPr>
            <a:xfrm>
              <a:off x="7678800" y="1500120"/>
              <a:ext cx="284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%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1" name="Group 247"/>
          <p:cNvGrpSpPr/>
          <p:nvPr/>
        </p:nvGrpSpPr>
        <p:grpSpPr>
          <a:xfrm>
            <a:off x="8108280" y="1189080"/>
            <a:ext cx="932760" cy="646200"/>
            <a:chOff x="8108280" y="1189080"/>
            <a:chExt cx="932760" cy="646200"/>
          </a:xfrm>
        </p:grpSpPr>
        <p:sp>
          <p:nvSpPr>
            <p:cNvPr id="92" name="TextBox 263"/>
            <p:cNvSpPr/>
            <p:nvPr/>
          </p:nvSpPr>
          <p:spPr>
            <a:xfrm>
              <a:off x="8108280" y="1189080"/>
              <a:ext cx="2674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TextBox 261"/>
            <p:cNvSpPr/>
            <p:nvPr/>
          </p:nvSpPr>
          <p:spPr>
            <a:xfrm>
              <a:off x="8475840" y="1394280"/>
              <a:ext cx="284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7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%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TextBox 259"/>
            <p:cNvSpPr/>
            <p:nvPr/>
          </p:nvSpPr>
          <p:spPr>
            <a:xfrm>
              <a:off x="8756640" y="1497960"/>
              <a:ext cx="284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%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5" name="TextBox 288"/>
          <p:cNvSpPr/>
          <p:nvPr/>
        </p:nvSpPr>
        <p:spPr>
          <a:xfrm>
            <a:off x="5300640" y="1616040"/>
            <a:ext cx="552600" cy="335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Dynamic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warm u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6" name="Group 6"/>
          <p:cNvGrpSpPr/>
          <p:nvPr/>
        </p:nvGrpSpPr>
        <p:grpSpPr>
          <a:xfrm>
            <a:off x="1492200" y="2060640"/>
            <a:ext cx="1573200" cy="271800"/>
            <a:chOff x="1492200" y="2060640"/>
            <a:chExt cx="1573200" cy="271800"/>
          </a:xfrm>
        </p:grpSpPr>
        <p:sp>
          <p:nvSpPr>
            <p:cNvPr id="97" name="TextBox 3"/>
            <p:cNvSpPr/>
            <p:nvPr/>
          </p:nvSpPr>
          <p:spPr>
            <a:xfrm>
              <a:off x="2037960" y="2086200"/>
              <a:ext cx="48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× 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Right Bracket 5"/>
            <p:cNvSpPr/>
            <p:nvPr/>
          </p:nvSpPr>
          <p:spPr>
            <a:xfrm flipH="1" rot="16200000">
              <a:off x="2255760" y="1297080"/>
              <a:ext cx="46080" cy="1573200"/>
            </a:xfrm>
            <a:custGeom>
              <a:avLst/>
              <a:gdLst>
                <a:gd name="textAreaLeft" fmla="*/ 0 w 46080"/>
                <a:gd name="textAreaRight" fmla="*/ 32400 w 46080"/>
                <a:gd name="textAreaTop" fmla="*/ 1080 h 1573200"/>
                <a:gd name="textAreaBottom" fmla="*/ 1572120 h 15732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17"/>
                    <a:pt x="21600" y="33"/>
                  </a:cubicBezTo>
                  <a:lnTo>
                    <a:pt x="21600" y="21567"/>
                  </a:lnTo>
                  <a:cubicBezTo>
                    <a:pt x="21600" y="21584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9" name="Straight Connector 224"/>
          <p:cNvSpPr/>
          <p:nvPr/>
        </p:nvSpPr>
        <p:spPr>
          <a:xfrm flipH="1">
            <a:off x="2212560" y="757080"/>
            <a:ext cx="5936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288"/>
          <p:cNvSpPr/>
          <p:nvPr/>
        </p:nvSpPr>
        <p:spPr>
          <a:xfrm>
            <a:off x="68400" y="1614600"/>
            <a:ext cx="996840" cy="335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Perceptual markers and creatine kinas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288"/>
          <p:cNvSpPr/>
          <p:nvPr/>
        </p:nvSpPr>
        <p:spPr>
          <a:xfrm>
            <a:off x="5964120" y="1614600"/>
            <a:ext cx="619200" cy="335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Functional measure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Rectangle 1"/>
          <p:cNvSpPr/>
          <p:nvPr/>
        </p:nvSpPr>
        <p:spPr>
          <a:xfrm>
            <a:off x="6692760" y="1195560"/>
            <a:ext cx="2160720" cy="758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2"/>
          <p:cNvSpPr/>
          <p:nvPr/>
        </p:nvSpPr>
        <p:spPr>
          <a:xfrm>
            <a:off x="6980400" y="1454040"/>
            <a:ext cx="158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Competitive football match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4" name="Group 370"/>
          <p:cNvGrpSpPr/>
          <p:nvPr/>
        </p:nvGrpSpPr>
        <p:grpSpPr>
          <a:xfrm>
            <a:off x="34920" y="2549520"/>
            <a:ext cx="8040960" cy="1705680"/>
            <a:chOff x="34920" y="2549520"/>
            <a:chExt cx="8040960" cy="1705680"/>
          </a:xfrm>
        </p:grpSpPr>
        <p:sp>
          <p:nvSpPr>
            <p:cNvPr id="105" name="Straight Connector 416"/>
            <p:cNvSpPr/>
            <p:nvPr/>
          </p:nvSpPr>
          <p:spPr>
            <a:xfrm>
              <a:off x="34920" y="4067280"/>
              <a:ext cx="3917880" cy="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Box 30"/>
            <p:cNvSpPr/>
            <p:nvPr/>
          </p:nvSpPr>
          <p:spPr>
            <a:xfrm>
              <a:off x="1069560" y="2549520"/>
              <a:ext cx="6667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Motor nerve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stimulation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07" name="Group 36"/>
            <p:cNvGrpSpPr/>
            <p:nvPr/>
          </p:nvGrpSpPr>
          <p:grpSpPr>
            <a:xfrm>
              <a:off x="1234080" y="2985480"/>
              <a:ext cx="267480" cy="1080000"/>
              <a:chOff x="1234080" y="2985480"/>
              <a:chExt cx="267480" cy="1080000"/>
            </a:xfrm>
          </p:grpSpPr>
          <p:sp>
            <p:nvSpPr>
              <p:cNvPr id="108" name="Rectangle 465"/>
              <p:cNvSpPr/>
              <p:nvPr/>
            </p:nvSpPr>
            <p:spPr>
              <a:xfrm>
                <a:off x="1314360" y="2985480"/>
                <a:ext cx="108000" cy="108000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TextBox 38"/>
              <p:cNvSpPr/>
              <p:nvPr/>
            </p:nvSpPr>
            <p:spPr>
              <a:xfrm>
                <a:off x="1234080" y="3303360"/>
                <a:ext cx="2674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V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C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10" name="TextBox 54"/>
            <p:cNvSpPr/>
            <p:nvPr/>
          </p:nvSpPr>
          <p:spPr>
            <a:xfrm>
              <a:off x="1361160" y="4028760"/>
              <a:ext cx="3254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anchor="t">
              <a:spAutoFit/>
            </a:bodyPr>
            <a:p>
              <a:pPr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rest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11" name="Group 182"/>
            <p:cNvGrpSpPr/>
            <p:nvPr/>
          </p:nvGrpSpPr>
          <p:grpSpPr>
            <a:xfrm>
              <a:off x="1908000" y="2549520"/>
              <a:ext cx="845280" cy="1520640"/>
              <a:chOff x="1908000" y="2549520"/>
              <a:chExt cx="845280" cy="1520640"/>
            </a:xfrm>
          </p:grpSpPr>
          <p:sp>
            <p:nvSpPr>
              <p:cNvPr id="112" name="TextBox 61"/>
              <p:cNvSpPr/>
              <p:nvPr/>
            </p:nvSpPr>
            <p:spPr>
              <a:xfrm>
                <a:off x="1996920" y="2549520"/>
                <a:ext cx="666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1" lang="en-GB" sz="700" spc="-1" strike="noStrike">
                    <a:solidFill>
                      <a:srgbClr val="000000"/>
                    </a:solidFill>
                    <a:latin typeface="Calibri"/>
                  </a:rPr>
                  <a:t>Motor cortex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1" lang="en-GB" sz="700" spc="-1" strike="noStrike">
                    <a:solidFill>
                      <a:srgbClr val="000000"/>
                    </a:solidFill>
                    <a:latin typeface="Calibri"/>
                  </a:rPr>
                  <a:t>stimulation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13" name="Group 55"/>
              <p:cNvGrpSpPr/>
              <p:nvPr/>
            </p:nvGrpSpPr>
            <p:grpSpPr>
              <a:xfrm>
                <a:off x="1908000" y="2985480"/>
                <a:ext cx="267480" cy="1080360"/>
                <a:chOff x="1908000" y="2985480"/>
                <a:chExt cx="267480" cy="1080360"/>
              </a:xfrm>
            </p:grpSpPr>
            <p:sp>
              <p:nvSpPr>
                <p:cNvPr id="114" name="Rectangle 463"/>
                <p:cNvSpPr/>
                <p:nvPr/>
              </p:nvSpPr>
              <p:spPr>
                <a:xfrm>
                  <a:off x="1977840" y="2985480"/>
                  <a:ext cx="117360" cy="1080360"/>
                </a:xfrm>
                <a:prstGeom prst="rect">
                  <a:avLst/>
                </a:prstGeom>
                <a:solidFill>
                  <a:srgbClr val="00000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" name="TextBox 57"/>
                <p:cNvSpPr/>
                <p:nvPr/>
              </p:nvSpPr>
              <p:spPr>
                <a:xfrm>
                  <a:off x="1908000" y="3303360"/>
                  <a:ext cx="267480" cy="459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en-GB" sz="800" spc="-1" strike="noStrike">
                      <a:solidFill>
                        <a:srgbClr val="ffffff"/>
                      </a:solidFill>
                      <a:latin typeface="Calibri"/>
                    </a:rPr>
                    <a:t>M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en-GB" sz="800" spc="-1" strike="noStrike">
                      <a:solidFill>
                        <a:srgbClr val="ffffff"/>
                      </a:solidFill>
                      <a:latin typeface="Calibri"/>
                    </a:rPr>
                    <a:t>V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en-GB" sz="800" spc="-1" strike="noStrike">
                      <a:solidFill>
                        <a:srgbClr val="ffffff"/>
                      </a:solidFill>
                      <a:latin typeface="Calibri"/>
                    </a:rPr>
                    <a:t>C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16" name="Group 58"/>
              <p:cNvGrpSpPr/>
              <p:nvPr/>
            </p:nvGrpSpPr>
            <p:grpSpPr>
              <a:xfrm>
                <a:off x="2187720" y="3255840"/>
                <a:ext cx="284400" cy="810360"/>
                <a:chOff x="2187720" y="3255840"/>
                <a:chExt cx="284400" cy="810360"/>
              </a:xfrm>
            </p:grpSpPr>
            <p:sp>
              <p:nvSpPr>
                <p:cNvPr id="117" name="Rectangle 461"/>
                <p:cNvSpPr/>
                <p:nvPr/>
              </p:nvSpPr>
              <p:spPr>
                <a:xfrm>
                  <a:off x="2274840" y="3255840"/>
                  <a:ext cx="109440" cy="810360"/>
                </a:xfrm>
                <a:prstGeom prst="rect">
                  <a:avLst/>
                </a:prstGeom>
                <a:solidFill>
                  <a:srgbClr val="00000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8" name="TextBox 60"/>
                <p:cNvSpPr/>
                <p:nvPr/>
              </p:nvSpPr>
              <p:spPr>
                <a:xfrm>
                  <a:off x="2187720" y="3509640"/>
                  <a:ext cx="28440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en-GB" sz="800" spc="-1" strike="noStrike">
                      <a:solidFill>
                        <a:srgbClr val="ffffff"/>
                      </a:solidFill>
                      <a:latin typeface="Calibri"/>
                    </a:rPr>
                    <a:t>75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en-GB" sz="800" spc="-1" strike="noStrike">
                      <a:solidFill>
                        <a:srgbClr val="ffffff"/>
                      </a:solidFill>
                      <a:latin typeface="Calibri"/>
                    </a:rPr>
                    <a:t>%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19" name="Group 62"/>
              <p:cNvGrpSpPr/>
              <p:nvPr/>
            </p:nvGrpSpPr>
            <p:grpSpPr>
              <a:xfrm>
                <a:off x="2468880" y="3530160"/>
                <a:ext cx="284400" cy="540000"/>
                <a:chOff x="2468880" y="3530160"/>
                <a:chExt cx="284400" cy="540000"/>
              </a:xfrm>
            </p:grpSpPr>
            <p:sp>
              <p:nvSpPr>
                <p:cNvPr id="120" name="Rectangle 459"/>
                <p:cNvSpPr/>
                <p:nvPr/>
              </p:nvSpPr>
              <p:spPr>
                <a:xfrm>
                  <a:off x="2556000" y="3530160"/>
                  <a:ext cx="109440" cy="540000"/>
                </a:xfrm>
                <a:prstGeom prst="rect">
                  <a:avLst/>
                </a:prstGeom>
                <a:solidFill>
                  <a:srgbClr val="00000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1" name="TextBox 64"/>
                <p:cNvSpPr/>
                <p:nvPr/>
              </p:nvSpPr>
              <p:spPr>
                <a:xfrm>
                  <a:off x="2468880" y="3611880"/>
                  <a:ext cx="28440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en-GB" sz="800" spc="-1" strike="noStrike">
                      <a:solidFill>
                        <a:srgbClr val="ffffff"/>
                      </a:solidFill>
                      <a:latin typeface="Calibri"/>
                    </a:rPr>
                    <a:t>5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r>
                    <a:rPr b="0" lang="en-GB" sz="800" spc="-1" strike="noStrike">
                      <a:solidFill>
                        <a:srgbClr val="ffffff"/>
                      </a:solidFill>
                      <a:latin typeface="Calibri"/>
                    </a:rPr>
                    <a:t>%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22" name="Group 174"/>
              <p:cNvGrpSpPr/>
              <p:nvPr/>
            </p:nvGrpSpPr>
            <p:grpSpPr>
              <a:xfrm>
                <a:off x="2030040" y="2875320"/>
                <a:ext cx="575280" cy="645120"/>
                <a:chOff x="2030040" y="2875320"/>
                <a:chExt cx="575280" cy="645120"/>
              </a:xfrm>
            </p:grpSpPr>
            <p:cxnSp>
              <p:nvCxnSpPr>
                <p:cNvPr id="123" name="Straight Arrow Connector 456"/>
                <p:cNvCxnSpPr/>
                <p:nvPr/>
              </p:nvCxnSpPr>
              <p:spPr>
                <a:xfrm>
                  <a:off x="2030040" y="2875320"/>
                  <a:ext cx="2160" cy="106920"/>
                </a:xfrm>
                <a:prstGeom prst="straightConnector1">
                  <a:avLst/>
                </a:prstGeom>
                <a:ln w="6480">
                  <a:solidFill>
                    <a:srgbClr val="000000"/>
                  </a:solidFill>
                  <a:miter/>
                  <a:tailEnd len="sm" type="triangle" w="sm"/>
                </a:ln>
              </p:spPr>
            </p:cxnSp>
            <p:cxnSp>
              <p:nvCxnSpPr>
                <p:cNvPr id="124" name="Straight Arrow Connector 457"/>
                <p:cNvCxnSpPr/>
                <p:nvPr/>
              </p:nvCxnSpPr>
              <p:spPr>
                <a:xfrm>
                  <a:off x="2324880" y="2875320"/>
                  <a:ext cx="1080" cy="375480"/>
                </a:xfrm>
                <a:prstGeom prst="straightConnector1">
                  <a:avLst/>
                </a:prstGeom>
                <a:ln w="6480">
                  <a:solidFill>
                    <a:srgbClr val="000000"/>
                  </a:solidFill>
                  <a:miter/>
                  <a:tailEnd len="sm" type="triangle" w="sm"/>
                </a:ln>
              </p:spPr>
            </p:cxnSp>
            <p:cxnSp>
              <p:nvCxnSpPr>
                <p:cNvPr id="125" name="Straight Arrow Connector 458"/>
                <p:cNvCxnSpPr/>
                <p:nvPr/>
              </p:nvCxnSpPr>
              <p:spPr>
                <a:xfrm>
                  <a:off x="2603520" y="2875320"/>
                  <a:ext cx="2160" cy="645480"/>
                </a:xfrm>
                <a:prstGeom prst="straightConnector1">
                  <a:avLst/>
                </a:prstGeom>
                <a:ln w="6480">
                  <a:solidFill>
                    <a:srgbClr val="000000"/>
                  </a:solidFill>
                  <a:miter/>
                  <a:tailEnd len="sm" type="triangle" w="sm"/>
                </a:ln>
              </p:spPr>
            </p:cxnSp>
          </p:grpSp>
        </p:grpSp>
        <p:sp>
          <p:nvSpPr>
            <p:cNvPr id="126" name="Straight Connector 422"/>
            <p:cNvSpPr/>
            <p:nvPr/>
          </p:nvSpPr>
          <p:spPr>
            <a:xfrm flipH="1">
              <a:off x="1360080" y="2867040"/>
              <a:ext cx="1602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127" name="Straight Arrow Connector 423"/>
            <p:cNvCxnSpPr/>
            <p:nvPr/>
          </p:nvCxnSpPr>
          <p:spPr>
            <a:xfrm>
              <a:off x="1363680" y="2869560"/>
              <a:ext cx="2160" cy="10836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sm" type="triangle" w="sm"/>
            </a:ln>
          </p:spPr>
        </p:cxnSp>
        <p:cxnSp>
          <p:nvCxnSpPr>
            <p:cNvPr id="128" name="Straight Arrow Connector 424"/>
            <p:cNvCxnSpPr/>
            <p:nvPr/>
          </p:nvCxnSpPr>
          <p:spPr>
            <a:xfrm>
              <a:off x="1520280" y="2866680"/>
              <a:ext cx="1080" cy="119124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sm" type="triangle" w="sm"/>
            </a:ln>
          </p:spPr>
        </p:cxnSp>
        <p:grpSp>
          <p:nvGrpSpPr>
            <p:cNvPr id="129" name="Group 208"/>
            <p:cNvGrpSpPr/>
            <p:nvPr/>
          </p:nvGrpSpPr>
          <p:grpSpPr>
            <a:xfrm>
              <a:off x="1624680" y="4000320"/>
              <a:ext cx="304200" cy="254520"/>
              <a:chOff x="1624680" y="4000320"/>
              <a:chExt cx="304200" cy="254520"/>
            </a:xfrm>
          </p:grpSpPr>
          <p:grpSp>
            <p:nvGrpSpPr>
              <p:cNvPr id="130" name="Group 209"/>
              <p:cNvGrpSpPr/>
              <p:nvPr/>
            </p:nvGrpSpPr>
            <p:grpSpPr>
              <a:xfrm>
                <a:off x="1757160" y="4000320"/>
                <a:ext cx="74160" cy="123120"/>
                <a:chOff x="1757160" y="4000320"/>
                <a:chExt cx="74160" cy="123120"/>
              </a:xfrm>
            </p:grpSpPr>
            <p:sp>
              <p:nvSpPr>
                <p:cNvPr id="131" name="Rounded Rectangle 211"/>
                <p:cNvSpPr/>
                <p:nvPr/>
              </p:nvSpPr>
              <p:spPr>
                <a:xfrm>
                  <a:off x="1779120" y="4000320"/>
                  <a:ext cx="36360" cy="123120"/>
                </a:xfrm>
                <a:custGeom>
                  <a:avLst/>
                  <a:gdLst>
                    <a:gd name="textAreaLeft" fmla="*/ 1440 w 36360"/>
                    <a:gd name="textAreaRight" fmla="*/ 34920 w 36360"/>
                    <a:gd name="textAreaTop" fmla="*/ 1440 h 123120"/>
                    <a:gd name="textAreaBottom" fmla="*/ 121680 h 123120"/>
                  </a:gdLst>
                  <a:ahLst/>
                  <a:rect l="textAreaLeft" t="textAreaTop" r="textAreaRight" b="textAreaBottom"/>
                  <a:pathLst>
                    <a:path w="21600" h="72635">
                      <a:moveTo>
                        <a:pt x="3600" y="0"/>
                      </a:moveTo>
                      <a:arcTo wR="3600" hR="3600" stAng="16200000" swAng="-5400000"/>
                      <a:lnTo>
                        <a:pt x="0" y="69035"/>
                      </a:lnTo>
                      <a:arcTo wR="3600" hR="3600" stAng="10800000" swAng="-5400000"/>
                      <a:lnTo>
                        <a:pt x="18000" y="72635"/>
                      </a:lnTo>
                      <a:arcTo wR="3600" hR="3600" stAng="5400000" swAng="-5400000"/>
                      <a:lnTo>
                        <a:pt x="21600" y="3600"/>
                      </a:lnTo>
                      <a:arcTo wR="3600" hR="3600" stAng="0" swAng="-5400000"/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2" name="Straight Connector 449"/>
                <p:cNvSpPr/>
                <p:nvPr/>
              </p:nvSpPr>
              <p:spPr>
                <a:xfrm flipV="1">
                  <a:off x="1757160" y="4024800"/>
                  <a:ext cx="36360" cy="655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720" bIns="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3" name="Straight Connector 450"/>
                <p:cNvSpPr/>
                <p:nvPr/>
              </p:nvSpPr>
              <p:spPr>
                <a:xfrm flipV="1">
                  <a:off x="1794960" y="4026240"/>
                  <a:ext cx="36360" cy="698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040" bIns="23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34" name="TextBox 210"/>
              <p:cNvSpPr/>
              <p:nvPr/>
            </p:nvSpPr>
            <p:spPr>
              <a:xfrm>
                <a:off x="1624680" y="4069440"/>
                <a:ext cx="304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1" lang="en-GB" sz="600" spc="-1" strike="noStrike">
                    <a:solidFill>
                      <a:srgbClr val="000000"/>
                    </a:solidFill>
                    <a:latin typeface="Calibri"/>
                  </a:rPr>
                  <a:t>15 s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35" name="Group 214"/>
            <p:cNvGrpSpPr/>
            <p:nvPr/>
          </p:nvGrpSpPr>
          <p:grpSpPr>
            <a:xfrm>
              <a:off x="2622240" y="4002120"/>
              <a:ext cx="304200" cy="253080"/>
              <a:chOff x="2622240" y="4002120"/>
              <a:chExt cx="304200" cy="253080"/>
            </a:xfrm>
          </p:grpSpPr>
          <p:grpSp>
            <p:nvGrpSpPr>
              <p:cNvPr id="136" name="Group 215"/>
              <p:cNvGrpSpPr/>
              <p:nvPr/>
            </p:nvGrpSpPr>
            <p:grpSpPr>
              <a:xfrm>
                <a:off x="2754000" y="4002120"/>
                <a:ext cx="74520" cy="125280"/>
                <a:chOff x="2754000" y="4002120"/>
                <a:chExt cx="74520" cy="125280"/>
              </a:xfrm>
            </p:grpSpPr>
            <p:sp>
              <p:nvSpPr>
                <p:cNvPr id="137" name="Rounded Rectangle 217"/>
                <p:cNvSpPr/>
                <p:nvPr/>
              </p:nvSpPr>
              <p:spPr>
                <a:xfrm>
                  <a:off x="2775960" y="4002120"/>
                  <a:ext cx="36360" cy="125280"/>
                </a:xfrm>
                <a:custGeom>
                  <a:avLst/>
                  <a:gdLst>
                    <a:gd name="textAreaLeft" fmla="*/ 1440 w 36360"/>
                    <a:gd name="textAreaRight" fmla="*/ 34920 w 36360"/>
                    <a:gd name="textAreaTop" fmla="*/ 1440 h 125280"/>
                    <a:gd name="textAreaBottom" fmla="*/ 123840 h 125280"/>
                  </a:gdLst>
                  <a:ahLst/>
                  <a:rect l="textAreaLeft" t="textAreaTop" r="textAreaRight" b="textAreaBottom"/>
                  <a:pathLst>
                    <a:path w="21600" h="73906">
                      <a:moveTo>
                        <a:pt x="3600" y="0"/>
                      </a:moveTo>
                      <a:arcTo wR="3600" hR="3600" stAng="16200000" swAng="-5400000"/>
                      <a:lnTo>
                        <a:pt x="0" y="70306"/>
                      </a:lnTo>
                      <a:arcTo wR="3600" hR="3600" stAng="10800000" swAng="-5400000"/>
                      <a:lnTo>
                        <a:pt x="18000" y="73906"/>
                      </a:lnTo>
                      <a:arcTo wR="3600" hR="3600" stAng="5400000" swAng="-5400000"/>
                      <a:lnTo>
                        <a:pt x="21600" y="3600"/>
                      </a:lnTo>
                      <a:arcTo wR="3600" hR="3600" stAng="0" swAng="-5400000"/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2960"/>
                      <a:tab algn="l" pos="1825560"/>
                      <a:tab algn="l" pos="2738520"/>
                      <a:tab algn="l" pos="3651120"/>
                      <a:tab algn="l" pos="4564080"/>
                      <a:tab algn="l" pos="5477040"/>
                      <a:tab algn="l" pos="6389640"/>
                      <a:tab algn="l" pos="7302600"/>
                      <a:tab algn="l" pos="8215200"/>
                      <a:tab algn="l" pos="9128160"/>
                      <a:tab algn="l" pos="10040760"/>
                      <a:tab algn="l" pos="1095372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8" name="Straight Connector 444"/>
                <p:cNvSpPr/>
                <p:nvPr/>
              </p:nvSpPr>
              <p:spPr>
                <a:xfrm flipV="1">
                  <a:off x="2754000" y="4032000"/>
                  <a:ext cx="36360" cy="712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4480" bIns="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9" name="Straight Connector 445"/>
                <p:cNvSpPr/>
                <p:nvPr/>
              </p:nvSpPr>
              <p:spPr>
                <a:xfrm flipV="1">
                  <a:off x="2792160" y="4033440"/>
                  <a:ext cx="36360" cy="73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6280" bIns="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40" name="TextBox 216"/>
              <p:cNvSpPr/>
              <p:nvPr/>
            </p:nvSpPr>
            <p:spPr>
              <a:xfrm>
                <a:off x="2622240" y="4069800"/>
                <a:ext cx="304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1" lang="en-GB" sz="600" spc="-1" strike="noStrike">
                    <a:solidFill>
                      <a:srgbClr val="000000"/>
                    </a:solidFill>
                    <a:latin typeface="Calibri"/>
                  </a:rPr>
                  <a:t>20 s</a:t>
                </a:r>
                <a:endParaRPr b="0" lang="en-US" sz="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41" name="TextBox 242"/>
            <p:cNvSpPr/>
            <p:nvPr/>
          </p:nvSpPr>
          <p:spPr>
            <a:xfrm>
              <a:off x="7791480" y="3616200"/>
              <a:ext cx="284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%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42" name="Group 6"/>
          <p:cNvGrpSpPr/>
          <p:nvPr/>
        </p:nvGrpSpPr>
        <p:grpSpPr>
          <a:xfrm>
            <a:off x="1256760" y="4203720"/>
            <a:ext cx="1571400" cy="268920"/>
            <a:chOff x="1256760" y="4203720"/>
            <a:chExt cx="1571400" cy="268920"/>
          </a:xfrm>
        </p:grpSpPr>
        <p:sp>
          <p:nvSpPr>
            <p:cNvPr id="143" name="TextBox 3"/>
            <p:cNvSpPr/>
            <p:nvPr/>
          </p:nvSpPr>
          <p:spPr>
            <a:xfrm>
              <a:off x="1801440" y="4226400"/>
              <a:ext cx="48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× 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Right Bracket 415"/>
            <p:cNvSpPr/>
            <p:nvPr/>
          </p:nvSpPr>
          <p:spPr>
            <a:xfrm flipH="1" rot="16200000">
              <a:off x="2019600" y="3440520"/>
              <a:ext cx="45000" cy="1571400"/>
            </a:xfrm>
            <a:custGeom>
              <a:avLst/>
              <a:gdLst>
                <a:gd name="textAreaLeft" fmla="*/ -360 w 45000"/>
                <a:gd name="textAreaRight" fmla="*/ 31320 w 45000"/>
                <a:gd name="textAreaTop" fmla="*/ 1080 h 1571400"/>
                <a:gd name="textAreaBottom" fmla="*/ 1570320 h 15714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16"/>
                    <a:pt x="21600" y="32"/>
                  </a:cubicBezTo>
                  <a:lnTo>
                    <a:pt x="21600" y="21568"/>
                  </a:lnTo>
                  <a:cubicBezTo>
                    <a:pt x="21600" y="21584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45" name="Straight Connector 409"/>
          <p:cNvSpPr/>
          <p:nvPr/>
        </p:nvSpPr>
        <p:spPr>
          <a:xfrm flipH="1">
            <a:off x="2026800" y="2878200"/>
            <a:ext cx="5763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Box 6"/>
          <p:cNvSpPr/>
          <p:nvPr/>
        </p:nvSpPr>
        <p:spPr>
          <a:xfrm>
            <a:off x="50760" y="189000"/>
            <a:ext cx="120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Pre-matc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467"/>
          <p:cNvSpPr/>
          <p:nvPr/>
        </p:nvSpPr>
        <p:spPr>
          <a:xfrm>
            <a:off x="34920" y="2246400"/>
            <a:ext cx="129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Post-matc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Box 467"/>
          <p:cNvSpPr/>
          <p:nvPr/>
        </p:nvSpPr>
        <p:spPr>
          <a:xfrm>
            <a:off x="46080" y="4508640"/>
            <a:ext cx="180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24, 48 and 72 h pos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Box 34"/>
          <p:cNvSpPr/>
          <p:nvPr/>
        </p:nvSpPr>
        <p:spPr>
          <a:xfrm>
            <a:off x="74160" y="5715000"/>
            <a:ext cx="267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V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0" name="Group 231"/>
          <p:cNvGrpSpPr/>
          <p:nvPr/>
        </p:nvGrpSpPr>
        <p:grpSpPr>
          <a:xfrm>
            <a:off x="7147800" y="5716440"/>
            <a:ext cx="843840" cy="646200"/>
            <a:chOff x="7147800" y="5716440"/>
            <a:chExt cx="843840" cy="646200"/>
          </a:xfrm>
        </p:grpSpPr>
        <p:sp>
          <p:nvSpPr>
            <p:cNvPr id="151" name="TextBox 246"/>
            <p:cNvSpPr/>
            <p:nvPr/>
          </p:nvSpPr>
          <p:spPr>
            <a:xfrm>
              <a:off x="7147800" y="5716440"/>
              <a:ext cx="2674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TextBox 242"/>
            <p:cNvSpPr/>
            <p:nvPr/>
          </p:nvSpPr>
          <p:spPr>
            <a:xfrm>
              <a:off x="7707240" y="6025320"/>
              <a:ext cx="284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%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53" name="Group 247"/>
          <p:cNvGrpSpPr/>
          <p:nvPr/>
        </p:nvGrpSpPr>
        <p:grpSpPr>
          <a:xfrm>
            <a:off x="8136720" y="5715000"/>
            <a:ext cx="932760" cy="646200"/>
            <a:chOff x="8136720" y="5715000"/>
            <a:chExt cx="932760" cy="646200"/>
          </a:xfrm>
        </p:grpSpPr>
        <p:sp>
          <p:nvSpPr>
            <p:cNvPr id="154" name="TextBox 263"/>
            <p:cNvSpPr/>
            <p:nvPr/>
          </p:nvSpPr>
          <p:spPr>
            <a:xfrm>
              <a:off x="8136720" y="5715000"/>
              <a:ext cx="2674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TextBox 261"/>
            <p:cNvSpPr/>
            <p:nvPr/>
          </p:nvSpPr>
          <p:spPr>
            <a:xfrm>
              <a:off x="8504280" y="5920200"/>
              <a:ext cx="284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7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%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TextBox 259"/>
            <p:cNvSpPr/>
            <p:nvPr/>
          </p:nvSpPr>
          <p:spPr>
            <a:xfrm>
              <a:off x="8785080" y="6023880"/>
              <a:ext cx="284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%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7" name="TextBox 2"/>
          <p:cNvSpPr/>
          <p:nvPr/>
        </p:nvSpPr>
        <p:spPr>
          <a:xfrm>
            <a:off x="4259160" y="3164040"/>
            <a:ext cx="3673440" cy="167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Digital Content 1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Schematic of experimental protocol. Pre-match and at 24, 48 and 72 h post participants completed a battery of perceptual, neuromuscular and functional assessments in the same order. After the pre-match assessment, participants completed a 90 min competitive soccer match consisting of two 45 minute halves interspersed by a 15 min rest interval. For the post-match assessment, a “conveyer belt” system was applied, whereby one player finished one set of tests, and the subsequent player began testing. Single- and paired-pulse TMS were administered in 2 sets of 10 stimuli during a light voluntary contraction (10% maximal voluntary contraction (MVC)). For the recruitment curve, five stimuli were delivered at each of 90%, 100%, 110%, 120%, 130%, 140%, 150% and 160% of AMT in a randomized order during a 10% MVC.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Box 38"/>
          <p:cNvSpPr/>
          <p:nvPr/>
        </p:nvSpPr>
        <p:spPr>
          <a:xfrm>
            <a:off x="1104840" y="1204920"/>
            <a:ext cx="284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V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9" name="Group 6"/>
          <p:cNvGrpSpPr/>
          <p:nvPr/>
        </p:nvGrpSpPr>
        <p:grpSpPr>
          <a:xfrm>
            <a:off x="1042920" y="2060640"/>
            <a:ext cx="490680" cy="272160"/>
            <a:chOff x="1042920" y="2060640"/>
            <a:chExt cx="490680" cy="272160"/>
          </a:xfrm>
        </p:grpSpPr>
        <p:sp>
          <p:nvSpPr>
            <p:cNvPr id="160" name="TextBox 3"/>
            <p:cNvSpPr/>
            <p:nvPr/>
          </p:nvSpPr>
          <p:spPr>
            <a:xfrm>
              <a:off x="1042920" y="2086560"/>
              <a:ext cx="490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× 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Right Bracket 180"/>
            <p:cNvSpPr/>
            <p:nvPr/>
          </p:nvSpPr>
          <p:spPr>
            <a:xfrm flipH="1" rot="16200000">
              <a:off x="1230120" y="1902960"/>
              <a:ext cx="45720" cy="360720"/>
            </a:xfrm>
            <a:custGeom>
              <a:avLst/>
              <a:gdLst>
                <a:gd name="textAreaLeft" fmla="*/ 0 w 45720"/>
                <a:gd name="textAreaRight" fmla="*/ 32040 w 45720"/>
                <a:gd name="textAreaTop" fmla="*/ 1080 h 360720"/>
                <a:gd name="textAreaBottom" fmla="*/ 359640 h 3607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73"/>
                    <a:pt x="21600" y="145"/>
                  </a:cubicBezTo>
                  <a:lnTo>
                    <a:pt x="21600" y="21455"/>
                  </a:lnTo>
                  <a:cubicBezTo>
                    <a:pt x="21600" y="21528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62" name="TextBox 38"/>
          <p:cNvSpPr/>
          <p:nvPr/>
        </p:nvSpPr>
        <p:spPr>
          <a:xfrm>
            <a:off x="1144440" y="5732640"/>
            <a:ext cx="284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V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Straight Connector 186"/>
          <p:cNvSpPr/>
          <p:nvPr/>
        </p:nvSpPr>
        <p:spPr>
          <a:xfrm>
            <a:off x="57240" y="6486480"/>
            <a:ext cx="7792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TextBox 30"/>
          <p:cNvSpPr/>
          <p:nvPr/>
        </p:nvSpPr>
        <p:spPr>
          <a:xfrm>
            <a:off x="1292040" y="4962600"/>
            <a:ext cx="6667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GB" sz="700" spc="-1" strike="noStrike">
                <a:solidFill>
                  <a:srgbClr val="000000"/>
                </a:solidFill>
                <a:latin typeface="Calibri"/>
              </a:rPr>
              <a:t>Motor nerve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GB" sz="700" spc="-1" strike="noStrike">
                <a:solidFill>
                  <a:srgbClr val="000000"/>
                </a:solidFill>
                <a:latin typeface="Calibri"/>
              </a:rPr>
              <a:t>stimulation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65" name="Group 36"/>
          <p:cNvGrpSpPr/>
          <p:nvPr/>
        </p:nvGrpSpPr>
        <p:grpSpPr>
          <a:xfrm>
            <a:off x="1485360" y="5398920"/>
            <a:ext cx="267480" cy="1079640"/>
            <a:chOff x="1485360" y="5398920"/>
            <a:chExt cx="267480" cy="1079640"/>
          </a:xfrm>
        </p:grpSpPr>
        <p:sp>
          <p:nvSpPr>
            <p:cNvPr id="166" name="Rectangle 189"/>
            <p:cNvSpPr/>
            <p:nvPr/>
          </p:nvSpPr>
          <p:spPr>
            <a:xfrm>
              <a:off x="1565280" y="5398920"/>
              <a:ext cx="108000" cy="10796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TextBox 38"/>
            <p:cNvSpPr/>
            <p:nvPr/>
          </p:nvSpPr>
          <p:spPr>
            <a:xfrm>
              <a:off x="1485360" y="5718600"/>
              <a:ext cx="2674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68" name="Group 182"/>
          <p:cNvGrpSpPr/>
          <p:nvPr/>
        </p:nvGrpSpPr>
        <p:grpSpPr>
          <a:xfrm>
            <a:off x="2129760" y="4962600"/>
            <a:ext cx="845280" cy="1519200"/>
            <a:chOff x="2129760" y="4962600"/>
            <a:chExt cx="845280" cy="1519200"/>
          </a:xfrm>
        </p:grpSpPr>
        <p:sp>
          <p:nvSpPr>
            <p:cNvPr id="169" name="TextBox 61"/>
            <p:cNvSpPr/>
            <p:nvPr/>
          </p:nvSpPr>
          <p:spPr>
            <a:xfrm>
              <a:off x="2218680" y="4962600"/>
              <a:ext cx="666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Motor cortex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Calibri"/>
                </a:rPr>
                <a:t>stimulation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70" name="Group 55"/>
            <p:cNvGrpSpPr/>
            <p:nvPr/>
          </p:nvGrpSpPr>
          <p:grpSpPr>
            <a:xfrm>
              <a:off x="2129760" y="5398200"/>
              <a:ext cx="267480" cy="1079280"/>
              <a:chOff x="2129760" y="5398200"/>
              <a:chExt cx="267480" cy="1079280"/>
            </a:xfrm>
          </p:grpSpPr>
          <p:sp>
            <p:nvSpPr>
              <p:cNvPr id="171" name="Rectangle 207"/>
              <p:cNvSpPr/>
              <p:nvPr/>
            </p:nvSpPr>
            <p:spPr>
              <a:xfrm>
                <a:off x="2200320" y="5398200"/>
                <a:ext cx="117360" cy="107928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2" name="TextBox 57"/>
              <p:cNvSpPr/>
              <p:nvPr/>
            </p:nvSpPr>
            <p:spPr>
              <a:xfrm>
                <a:off x="2129760" y="5718240"/>
                <a:ext cx="26748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M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V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C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73" name="Group 58"/>
            <p:cNvGrpSpPr/>
            <p:nvPr/>
          </p:nvGrpSpPr>
          <p:grpSpPr>
            <a:xfrm>
              <a:off x="2409480" y="5668200"/>
              <a:ext cx="284400" cy="809280"/>
              <a:chOff x="2409480" y="5668200"/>
              <a:chExt cx="284400" cy="809280"/>
            </a:xfrm>
          </p:grpSpPr>
          <p:sp>
            <p:nvSpPr>
              <p:cNvPr id="174" name="Rectangle 205"/>
              <p:cNvSpPr/>
              <p:nvPr/>
            </p:nvSpPr>
            <p:spPr>
              <a:xfrm>
                <a:off x="2496960" y="5668200"/>
                <a:ext cx="109440" cy="80928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TextBox 60"/>
              <p:cNvSpPr/>
              <p:nvPr/>
            </p:nvSpPr>
            <p:spPr>
              <a:xfrm>
                <a:off x="2409480" y="5923440"/>
                <a:ext cx="2844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7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%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76" name="Group 62"/>
            <p:cNvGrpSpPr/>
            <p:nvPr/>
          </p:nvGrpSpPr>
          <p:grpSpPr>
            <a:xfrm>
              <a:off x="2690640" y="5942520"/>
              <a:ext cx="284400" cy="539280"/>
              <a:chOff x="2690640" y="5942520"/>
              <a:chExt cx="284400" cy="539280"/>
            </a:xfrm>
          </p:grpSpPr>
          <p:sp>
            <p:nvSpPr>
              <p:cNvPr id="177" name="Rectangle 203"/>
              <p:cNvSpPr/>
              <p:nvPr/>
            </p:nvSpPr>
            <p:spPr>
              <a:xfrm>
                <a:off x="2778120" y="5942520"/>
                <a:ext cx="109440" cy="53928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TextBox 64"/>
              <p:cNvSpPr/>
              <p:nvPr/>
            </p:nvSpPr>
            <p:spPr>
              <a:xfrm>
                <a:off x="2690640" y="6026400"/>
                <a:ext cx="2844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r>
                  <a:rPr b="0" lang="en-GB" sz="800" spc="-1" strike="noStrike">
                    <a:solidFill>
                      <a:srgbClr val="ffffff"/>
                    </a:solidFill>
                    <a:latin typeface="Calibri"/>
                  </a:rPr>
                  <a:t>%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79" name="Group 174"/>
            <p:cNvGrpSpPr/>
            <p:nvPr/>
          </p:nvGrpSpPr>
          <p:grpSpPr>
            <a:xfrm>
              <a:off x="2242800" y="5288040"/>
              <a:ext cx="583920" cy="644400"/>
              <a:chOff x="2242800" y="5288040"/>
              <a:chExt cx="583920" cy="644400"/>
            </a:xfrm>
          </p:grpSpPr>
          <p:cxnSp>
            <p:nvCxnSpPr>
              <p:cNvPr id="180" name="Straight Arrow Connector 200"/>
              <p:cNvCxnSpPr/>
              <p:nvPr/>
            </p:nvCxnSpPr>
            <p:spPr>
              <a:xfrm>
                <a:off x="2242800" y="5288040"/>
                <a:ext cx="2160" cy="106920"/>
              </a:xfrm>
              <a:prstGeom prst="straightConnector1">
                <a:avLst/>
              </a:prstGeom>
              <a:ln w="648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81" name="Straight Arrow Connector 201"/>
              <p:cNvCxnSpPr/>
              <p:nvPr/>
            </p:nvCxnSpPr>
            <p:spPr>
              <a:xfrm>
                <a:off x="2542320" y="5288400"/>
                <a:ext cx="1080" cy="375120"/>
              </a:xfrm>
              <a:prstGeom prst="straightConnector1">
                <a:avLst/>
              </a:prstGeom>
              <a:ln w="6480">
                <a:solidFill>
                  <a:srgbClr val="000000"/>
                </a:solidFill>
                <a:miter/>
                <a:tailEnd len="sm" type="triangle" w="sm"/>
              </a:ln>
            </p:spPr>
          </p:cxnSp>
          <p:cxnSp>
            <p:nvCxnSpPr>
              <p:cNvPr id="182" name="Straight Arrow Connector 202"/>
              <p:cNvCxnSpPr/>
              <p:nvPr/>
            </p:nvCxnSpPr>
            <p:spPr>
              <a:xfrm>
                <a:off x="2824920" y="5288040"/>
                <a:ext cx="2160" cy="644760"/>
              </a:xfrm>
              <a:prstGeom prst="straightConnector1">
                <a:avLst/>
              </a:prstGeom>
              <a:ln w="6480">
                <a:solidFill>
                  <a:srgbClr val="000000"/>
                </a:solidFill>
                <a:miter/>
                <a:tailEnd len="sm" type="triangle" w="sm"/>
              </a:ln>
            </p:spPr>
          </p:cxnSp>
        </p:grpSp>
      </p:grpSp>
      <p:sp>
        <p:nvSpPr>
          <p:cNvPr id="183" name="Straight Connector 209"/>
          <p:cNvSpPr/>
          <p:nvPr/>
        </p:nvSpPr>
        <p:spPr>
          <a:xfrm flipH="1">
            <a:off x="1604520" y="5280120"/>
            <a:ext cx="1666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84" name="Straight Arrow Connector 210"/>
          <p:cNvCxnSpPr/>
          <p:nvPr/>
        </p:nvCxnSpPr>
        <p:spPr>
          <a:xfrm>
            <a:off x="1771200" y="5280120"/>
            <a:ext cx="1080" cy="11876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grpSp>
        <p:nvGrpSpPr>
          <p:cNvPr id="185" name="Group 209"/>
          <p:cNvGrpSpPr/>
          <p:nvPr/>
        </p:nvGrpSpPr>
        <p:grpSpPr>
          <a:xfrm>
            <a:off x="1965240" y="6411960"/>
            <a:ext cx="74520" cy="123840"/>
            <a:chOff x="1965240" y="6411960"/>
            <a:chExt cx="74520" cy="123840"/>
          </a:xfrm>
        </p:grpSpPr>
        <p:sp>
          <p:nvSpPr>
            <p:cNvPr id="186" name="Rounded Rectangle 215"/>
            <p:cNvSpPr/>
            <p:nvPr/>
          </p:nvSpPr>
          <p:spPr>
            <a:xfrm>
              <a:off x="1987200" y="6411960"/>
              <a:ext cx="36360" cy="123840"/>
            </a:xfrm>
            <a:custGeom>
              <a:avLst/>
              <a:gdLst>
                <a:gd name="textAreaLeft" fmla="*/ 1440 w 36360"/>
                <a:gd name="textAreaRight" fmla="*/ 34920 w 36360"/>
                <a:gd name="textAreaTop" fmla="*/ 1440 h 123840"/>
                <a:gd name="textAreaBottom" fmla="*/ 122400 h 123840"/>
              </a:gdLst>
              <a:ahLst/>
              <a:rect l="textAreaLeft" t="textAreaTop" r="textAreaRight" b="textAreaBottom"/>
              <a:pathLst>
                <a:path w="21600" h="73059">
                  <a:moveTo>
                    <a:pt x="3600" y="0"/>
                  </a:moveTo>
                  <a:arcTo wR="3600" hR="3600" stAng="16200000" swAng="-5400000"/>
                  <a:lnTo>
                    <a:pt x="0" y="69459"/>
                  </a:lnTo>
                  <a:arcTo wR="3600" hR="3600" stAng="10800000" swAng="-5400000"/>
                  <a:lnTo>
                    <a:pt x="18000" y="73059"/>
                  </a:lnTo>
                  <a:arcTo wR="3600" hR="3600" stAng="5400000" swAng="-5400000"/>
                  <a:lnTo>
                    <a:pt x="21600" y="3600"/>
                  </a:lnTo>
                  <a:arcTo wR="3600" hR="3600" stAng="0" swAng="-5400000"/>
                  <a:close/>
                </a:path>
              </a:pathLst>
            </a:cu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Straight Connector 216"/>
            <p:cNvSpPr/>
            <p:nvPr/>
          </p:nvSpPr>
          <p:spPr>
            <a:xfrm flipV="1">
              <a:off x="1965240" y="6436800"/>
              <a:ext cx="36360" cy="65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Straight Connector 220"/>
            <p:cNvSpPr/>
            <p:nvPr/>
          </p:nvSpPr>
          <p:spPr>
            <a:xfrm flipV="1">
              <a:off x="2003400" y="6437880"/>
              <a:ext cx="36360" cy="69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89" name="TextBox 210"/>
          <p:cNvSpPr/>
          <p:nvPr/>
        </p:nvSpPr>
        <p:spPr>
          <a:xfrm>
            <a:off x="1829880" y="6481800"/>
            <a:ext cx="304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GB" sz="600" spc="-1" strike="noStrike">
                <a:solidFill>
                  <a:srgbClr val="000000"/>
                </a:solidFill>
                <a:latin typeface="Calibri"/>
              </a:rPr>
              <a:t>90 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90" name="Group 214"/>
          <p:cNvGrpSpPr/>
          <p:nvPr/>
        </p:nvGrpSpPr>
        <p:grpSpPr>
          <a:xfrm>
            <a:off x="2816280" y="6413400"/>
            <a:ext cx="304200" cy="254520"/>
            <a:chOff x="2816280" y="6413400"/>
            <a:chExt cx="304200" cy="254520"/>
          </a:xfrm>
        </p:grpSpPr>
        <p:grpSp>
          <p:nvGrpSpPr>
            <p:cNvPr id="191" name="Group 215"/>
            <p:cNvGrpSpPr/>
            <p:nvPr/>
          </p:nvGrpSpPr>
          <p:grpSpPr>
            <a:xfrm>
              <a:off x="2948760" y="6413400"/>
              <a:ext cx="74520" cy="123480"/>
              <a:chOff x="2948760" y="6413400"/>
              <a:chExt cx="74520" cy="123480"/>
            </a:xfrm>
          </p:grpSpPr>
          <p:sp>
            <p:nvSpPr>
              <p:cNvPr id="192" name="Rounded Rectangle 227"/>
              <p:cNvSpPr/>
              <p:nvPr/>
            </p:nvSpPr>
            <p:spPr>
              <a:xfrm>
                <a:off x="2970720" y="6413400"/>
                <a:ext cx="36360" cy="123480"/>
              </a:xfrm>
              <a:custGeom>
                <a:avLst/>
                <a:gdLst>
                  <a:gd name="textAreaLeft" fmla="*/ 1440 w 36360"/>
                  <a:gd name="textAreaRight" fmla="*/ 34920 w 36360"/>
                  <a:gd name="textAreaTop" fmla="*/ 1440 h 123480"/>
                  <a:gd name="textAreaBottom" fmla="*/ 122040 h 123480"/>
                </a:gdLst>
                <a:ahLst/>
                <a:rect l="textAreaLeft" t="textAreaTop" r="textAreaRight" b="textAreaBottom"/>
                <a:pathLst>
                  <a:path w="21600" h="72847">
                    <a:moveTo>
                      <a:pt x="3600" y="0"/>
                    </a:moveTo>
                    <a:arcTo wR="3600" hR="3600" stAng="16200000" swAng="-5400000"/>
                    <a:lnTo>
                      <a:pt x="0" y="69247"/>
                    </a:lnTo>
                    <a:arcTo wR="3600" hR="3600" stAng="10800000" swAng="-5400000"/>
                    <a:lnTo>
                      <a:pt x="18000" y="72847"/>
                    </a:lnTo>
                    <a:arcTo wR="3600" hR="3600" stAng="5400000" swAng="-5400000"/>
                    <a:lnTo>
                      <a:pt x="21600" y="3600"/>
                    </a:lnTo>
                    <a:arcTo wR="3600" hR="3600" stAng="0" swAng="-5400000"/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2960"/>
                    <a:tab algn="l" pos="1825560"/>
                    <a:tab algn="l" pos="2738520"/>
                    <a:tab algn="l" pos="3651120"/>
                    <a:tab algn="l" pos="4564080"/>
                    <a:tab algn="l" pos="5477040"/>
                    <a:tab algn="l" pos="6389640"/>
                    <a:tab algn="l" pos="7302600"/>
                    <a:tab algn="l" pos="8215200"/>
                    <a:tab algn="l" pos="9128160"/>
                    <a:tab algn="l" pos="10040760"/>
                    <a:tab algn="l" pos="1095372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" name="Straight Connector 228"/>
              <p:cNvSpPr/>
              <p:nvPr/>
            </p:nvSpPr>
            <p:spPr>
              <a:xfrm flipV="1">
                <a:off x="2948760" y="6441840"/>
                <a:ext cx="36360" cy="712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" name="Straight Connector 229"/>
              <p:cNvSpPr/>
              <p:nvPr/>
            </p:nvSpPr>
            <p:spPr>
              <a:xfrm flipV="1">
                <a:off x="2986920" y="6443280"/>
                <a:ext cx="36360" cy="727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95" name="TextBox 216"/>
            <p:cNvSpPr/>
            <p:nvPr/>
          </p:nvSpPr>
          <p:spPr>
            <a:xfrm>
              <a:off x="2816280" y="6482520"/>
              <a:ext cx="304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1" lang="en-GB" sz="600" spc="-1" strike="noStrike">
                  <a:solidFill>
                    <a:srgbClr val="000000"/>
                  </a:solidFill>
                  <a:latin typeface="Calibri"/>
                </a:rPr>
                <a:t>90 s</a:t>
              </a:r>
              <a:endParaRPr b="0" lang="en-US" sz="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96" name="Group 220"/>
          <p:cNvGrpSpPr/>
          <p:nvPr/>
        </p:nvGrpSpPr>
        <p:grpSpPr>
          <a:xfrm>
            <a:off x="3054600" y="6224760"/>
            <a:ext cx="915120" cy="307080"/>
            <a:chOff x="3054600" y="6224760"/>
            <a:chExt cx="915120" cy="307080"/>
          </a:xfrm>
        </p:grpSpPr>
        <p:sp>
          <p:nvSpPr>
            <p:cNvPr id="197" name="Rectangle 231"/>
            <p:cNvSpPr/>
            <p:nvPr/>
          </p:nvSpPr>
          <p:spPr>
            <a:xfrm>
              <a:off x="3079440" y="6265800"/>
              <a:ext cx="864000" cy="2174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TextBox 222"/>
            <p:cNvSpPr/>
            <p:nvPr/>
          </p:nvSpPr>
          <p:spPr>
            <a:xfrm>
              <a:off x="3054600" y="6224760"/>
              <a:ext cx="91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Single and Paired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Calibri"/>
                </a:rPr>
                <a:t>Pulse TMS 10% MVC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99" name="TextBox 288"/>
          <p:cNvSpPr/>
          <p:nvPr/>
        </p:nvSpPr>
        <p:spPr>
          <a:xfrm>
            <a:off x="5392800" y="6141960"/>
            <a:ext cx="552240" cy="335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Dynamic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warm u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00" name="Group 6"/>
          <p:cNvGrpSpPr/>
          <p:nvPr/>
        </p:nvGrpSpPr>
        <p:grpSpPr>
          <a:xfrm>
            <a:off x="1514520" y="6589800"/>
            <a:ext cx="1573200" cy="271800"/>
            <a:chOff x="1514520" y="6589800"/>
            <a:chExt cx="1573200" cy="271800"/>
          </a:xfrm>
        </p:grpSpPr>
        <p:sp>
          <p:nvSpPr>
            <p:cNvPr id="201" name="TextBox 3"/>
            <p:cNvSpPr/>
            <p:nvPr/>
          </p:nvSpPr>
          <p:spPr>
            <a:xfrm>
              <a:off x="2060280" y="6615360"/>
              <a:ext cx="48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× 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Right Bracket 236"/>
            <p:cNvSpPr/>
            <p:nvPr/>
          </p:nvSpPr>
          <p:spPr>
            <a:xfrm flipH="1" rot="16200000">
              <a:off x="2278080" y="5826240"/>
              <a:ext cx="46080" cy="1573200"/>
            </a:xfrm>
            <a:custGeom>
              <a:avLst/>
              <a:gdLst>
                <a:gd name="textAreaLeft" fmla="*/ 0 w 46080"/>
                <a:gd name="textAreaRight" fmla="*/ 32400 w 46080"/>
                <a:gd name="textAreaTop" fmla="*/ 1080 h 1573200"/>
                <a:gd name="textAreaBottom" fmla="*/ 1572120 h 15732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17"/>
                    <a:pt x="21600" y="33"/>
                  </a:cubicBezTo>
                  <a:lnTo>
                    <a:pt x="21600" y="21567"/>
                  </a:lnTo>
                  <a:cubicBezTo>
                    <a:pt x="21600" y="21584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03" name="Straight Connector 237"/>
          <p:cNvSpPr/>
          <p:nvPr/>
        </p:nvSpPr>
        <p:spPr>
          <a:xfrm flipH="1">
            <a:off x="2238480" y="5286240"/>
            <a:ext cx="5889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TextBox 288"/>
          <p:cNvSpPr/>
          <p:nvPr/>
        </p:nvSpPr>
        <p:spPr>
          <a:xfrm>
            <a:off x="88920" y="6143760"/>
            <a:ext cx="998640" cy="335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Perceptual markers and creatine kinas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TextBox 288"/>
          <p:cNvSpPr/>
          <p:nvPr/>
        </p:nvSpPr>
        <p:spPr>
          <a:xfrm>
            <a:off x="6156360" y="6140520"/>
            <a:ext cx="620640" cy="335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Functional measure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Rectangle 240"/>
          <p:cNvSpPr/>
          <p:nvPr/>
        </p:nvSpPr>
        <p:spPr>
          <a:xfrm>
            <a:off x="1209600" y="5392800"/>
            <a:ext cx="117720" cy="10792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TextBox 38"/>
          <p:cNvSpPr/>
          <p:nvPr/>
        </p:nvSpPr>
        <p:spPr>
          <a:xfrm>
            <a:off x="1127160" y="5734080"/>
            <a:ext cx="284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V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ffffff"/>
                </a:solidFill>
                <a:latin typeface="Calibri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08" name="Group 6"/>
          <p:cNvGrpSpPr/>
          <p:nvPr/>
        </p:nvGrpSpPr>
        <p:grpSpPr>
          <a:xfrm>
            <a:off x="1065240" y="6589800"/>
            <a:ext cx="490680" cy="271800"/>
            <a:chOff x="1065240" y="6589800"/>
            <a:chExt cx="490680" cy="271800"/>
          </a:xfrm>
        </p:grpSpPr>
        <p:sp>
          <p:nvSpPr>
            <p:cNvPr id="209" name="TextBox 3"/>
            <p:cNvSpPr/>
            <p:nvPr/>
          </p:nvSpPr>
          <p:spPr>
            <a:xfrm>
              <a:off x="1065240" y="6615360"/>
              <a:ext cx="490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× 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Right Bracket 244"/>
            <p:cNvSpPr/>
            <p:nvPr/>
          </p:nvSpPr>
          <p:spPr>
            <a:xfrm flipH="1" rot="16200000">
              <a:off x="1252440" y="6432480"/>
              <a:ext cx="46080" cy="360720"/>
            </a:xfrm>
            <a:custGeom>
              <a:avLst/>
              <a:gdLst>
                <a:gd name="textAreaLeft" fmla="*/ 0 w 46080"/>
                <a:gd name="textAreaRight" fmla="*/ 32400 w 46080"/>
                <a:gd name="textAreaTop" fmla="*/ 1080 h 360720"/>
                <a:gd name="textAreaBottom" fmla="*/ 359640 h 3607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73"/>
                    <a:pt x="21600" y="146"/>
                  </a:cubicBezTo>
                  <a:lnTo>
                    <a:pt x="21600" y="21454"/>
                  </a:lnTo>
                  <a:cubicBezTo>
                    <a:pt x="21600" y="21527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211" name="Straight Arrow Connector 245"/>
          <p:cNvCxnSpPr/>
          <p:nvPr/>
        </p:nvCxnSpPr>
        <p:spPr>
          <a:xfrm>
            <a:off x="1606680" y="5281560"/>
            <a:ext cx="2160" cy="1087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sp>
        <p:nvSpPr>
          <p:cNvPr id="212" name="TextBox 54"/>
          <p:cNvSpPr/>
          <p:nvPr/>
        </p:nvSpPr>
        <p:spPr>
          <a:xfrm>
            <a:off x="1591560" y="6453360"/>
            <a:ext cx="32544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GB" sz="700" spc="-1" strike="noStrike">
                <a:solidFill>
                  <a:srgbClr val="000000"/>
                </a:solidFill>
                <a:latin typeface="Calibri"/>
              </a:rPr>
              <a:t>rest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TextBox 288"/>
          <p:cNvSpPr/>
          <p:nvPr/>
        </p:nvSpPr>
        <p:spPr>
          <a:xfrm>
            <a:off x="4076640" y="1646280"/>
            <a:ext cx="1077840" cy="3049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Calibri"/>
              </a:rPr>
              <a:t>Recruitment curve 90 -160% AMT 10% MVC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TextBox 288"/>
          <p:cNvSpPr/>
          <p:nvPr/>
        </p:nvSpPr>
        <p:spPr>
          <a:xfrm>
            <a:off x="68400" y="3719520"/>
            <a:ext cx="996840" cy="335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Perceptual markers and creatine kinas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15" name="Group 36"/>
          <p:cNvGrpSpPr/>
          <p:nvPr/>
        </p:nvGrpSpPr>
        <p:grpSpPr>
          <a:xfrm>
            <a:off x="1147320" y="865080"/>
            <a:ext cx="267480" cy="1079640"/>
            <a:chOff x="1147320" y="865080"/>
            <a:chExt cx="267480" cy="1079640"/>
          </a:xfrm>
        </p:grpSpPr>
        <p:sp>
          <p:nvSpPr>
            <p:cNvPr id="216" name="Rectangle 183"/>
            <p:cNvSpPr/>
            <p:nvPr/>
          </p:nvSpPr>
          <p:spPr>
            <a:xfrm>
              <a:off x="1226880" y="865080"/>
              <a:ext cx="108000" cy="10796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TextBox 38"/>
            <p:cNvSpPr/>
            <p:nvPr/>
          </p:nvSpPr>
          <p:spPr>
            <a:xfrm>
              <a:off x="1147320" y="1184760"/>
              <a:ext cx="2674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V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2960"/>
                  <a:tab algn="l" pos="1825560"/>
                  <a:tab algn="l" pos="2738520"/>
                  <a:tab algn="l" pos="3651120"/>
                  <a:tab algn="l" pos="4564080"/>
                  <a:tab algn="l" pos="5477040"/>
                  <a:tab algn="l" pos="6389640"/>
                  <a:tab algn="l" pos="7302600"/>
                  <a:tab algn="l" pos="8215200"/>
                  <a:tab algn="l" pos="9128160"/>
                  <a:tab algn="l" pos="10040760"/>
                  <a:tab algn="l" pos="10953720"/>
                </a:tabLst>
              </a:pPr>
              <a:r>
                <a:rPr b="0" lang="en-GB" sz="800" spc="-1" strike="noStrike">
                  <a:solidFill>
                    <a:srgbClr val="ffffff"/>
                  </a:solidFill>
                  <a:latin typeface="Calibri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18" name="TextBox 288"/>
          <p:cNvSpPr/>
          <p:nvPr/>
        </p:nvSpPr>
        <p:spPr>
          <a:xfrm>
            <a:off x="3024360" y="3733920"/>
            <a:ext cx="618840" cy="335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Calibri"/>
              </a:rPr>
              <a:t>Functional measure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TextBox 288"/>
          <p:cNvSpPr/>
          <p:nvPr/>
        </p:nvSpPr>
        <p:spPr>
          <a:xfrm>
            <a:off x="4083120" y="6180120"/>
            <a:ext cx="1079280" cy="3049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ctr"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0" lang="en-GB" sz="700" spc="-1" strike="noStrike">
                <a:solidFill>
                  <a:srgbClr val="000000"/>
                </a:solidFill>
                <a:latin typeface="Calibri"/>
              </a:rPr>
              <a:t>Recruitment curve 90 -160% AMT 10% MVC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20" name="Straight Arrow Connector 173"/>
          <p:cNvCxnSpPr/>
          <p:nvPr/>
        </p:nvCxnSpPr>
        <p:spPr>
          <a:xfrm>
            <a:off x="1847520" y="1636560"/>
            <a:ext cx="1080" cy="3024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sp>
        <p:nvSpPr>
          <p:cNvPr id="221" name="TextBox 3"/>
          <p:cNvSpPr/>
          <p:nvPr/>
        </p:nvSpPr>
        <p:spPr>
          <a:xfrm>
            <a:off x="1681200" y="1449360"/>
            <a:ext cx="361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GB" sz="700" spc="-1" strike="noStrike">
                <a:solidFill>
                  <a:srgbClr val="000000"/>
                </a:solidFill>
                <a:latin typeface="Calibri"/>
              </a:rPr>
              <a:t>1 Hz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22" name="Straight Arrow Connector 179"/>
          <p:cNvCxnSpPr/>
          <p:nvPr/>
        </p:nvCxnSpPr>
        <p:spPr>
          <a:xfrm>
            <a:off x="1633320" y="3752640"/>
            <a:ext cx="1080" cy="3020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sp>
        <p:nvSpPr>
          <p:cNvPr id="223" name="TextBox 181"/>
          <p:cNvSpPr/>
          <p:nvPr/>
        </p:nvSpPr>
        <p:spPr>
          <a:xfrm>
            <a:off x="1457280" y="3552840"/>
            <a:ext cx="362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GB" sz="700" spc="-1" strike="noStrike">
                <a:solidFill>
                  <a:srgbClr val="000000"/>
                </a:solidFill>
                <a:latin typeface="Calibri"/>
              </a:rPr>
              <a:t>1 Hz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24" name="Straight Arrow Connector 182"/>
          <p:cNvCxnSpPr/>
          <p:nvPr/>
        </p:nvCxnSpPr>
        <p:spPr>
          <a:xfrm>
            <a:off x="1872720" y="6165720"/>
            <a:ext cx="1080" cy="30240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sm" type="triangle" w="sm"/>
          </a:ln>
        </p:spPr>
      </p:cxnSp>
      <p:sp>
        <p:nvSpPr>
          <p:cNvPr id="225" name="TextBox 184"/>
          <p:cNvSpPr/>
          <p:nvPr/>
        </p:nvSpPr>
        <p:spPr>
          <a:xfrm>
            <a:off x="1722600" y="5994360"/>
            <a:ext cx="361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GB" sz="700" spc="-1" strike="noStrike">
                <a:solidFill>
                  <a:srgbClr val="000000"/>
                </a:solidFill>
                <a:latin typeface="Calibri"/>
              </a:rPr>
              <a:t>1 Hz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8-08T09:27:13Z</dcterms:created>
  <dc:creator>Stuart</dc:creator>
  <dc:description/>
  <dc:language>en-US</dc:language>
  <cp:lastModifiedBy>David Brownstein</cp:lastModifiedBy>
  <dcterms:modified xsi:type="dcterms:W3CDTF">2017-07-24T10:03:16Z</dcterms:modified>
  <cp:revision>58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1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1.PPT</vt:lpwstr>
  </property>
</Properties>
</file>